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9" r:id="rId2"/>
    <p:sldId id="320" r:id="rId3"/>
    <p:sldId id="321" r:id="rId4"/>
    <p:sldId id="310" r:id="rId5"/>
    <p:sldId id="311" r:id="rId6"/>
    <p:sldId id="312" r:id="rId7"/>
    <p:sldId id="313" r:id="rId8"/>
    <p:sldId id="314" r:id="rId9"/>
    <p:sldId id="315" r:id="rId10"/>
    <p:sldId id="318" r:id="rId11"/>
    <p:sldId id="317" r:id="rId12"/>
    <p:sldId id="316" r:id="rId13"/>
    <p:sldId id="306" r:id="rId1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1" d="100"/>
          <a:sy n="71" d="100"/>
        </p:scale>
        <p:origin x="78" y="8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8FDA320-98B3-4F34-9C4C-602EB4803B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E4E81176-D489-41E4-A6DF-5CB7BE0FE4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1110AA-ECC6-447C-8982-7579DAF11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58A6B1C-8CBA-4793-BF9A-707513E87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BD99F71-8FEE-4401-8247-F8946A743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8875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482F6DD-9FCB-4CD9-B794-D980A15BA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241CBDD-AB47-4CAF-95EC-AD0ABFEA57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DCCE7E5-AC8F-44CB-8BB4-7B94061CE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DB72CA0-1390-488A-BE58-7D96F47F42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92176C6-7CC2-4655-B709-1D0FB8E6F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8577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1B513390-395A-46B4-9437-9077A2921C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5203DDB-7B35-4813-9722-91E6F75D6B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308D66B-1602-4867-AB5E-4027782E4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EFAC16-8A7F-435B-8101-FFB57A6F3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0D644DA-3249-4A8D-A9F5-49235E659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155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FDD38A-8973-4179-A34E-F06CD210AE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0D32A4B-80FC-49D7-8650-B118C6F587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1D07807-2545-4988-9575-982FD3108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844EBF-EDBF-4C82-9143-19A307332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A13CEA8-8617-4938-B98D-F97B8C20E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667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BB3323B-3F55-4E2E-9AB9-F0B24D092F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B4EEF9E-22E6-4850-9864-197F611DE7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E3BE01D-2612-4EC9-9456-8CADAF29B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2AA4722-2155-4651-9EBD-E293A73CA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05497A6-2003-4896-A974-15D8AE62D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631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F94F5AF-43C9-41A7-8D82-83EBC513E1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4AB95E3-6FF0-43C1-86E9-B891626C7A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29A9113-99E9-46D6-A26E-005B4709B4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3F4352D-42FB-494E-872F-C7262A190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3CC9448-8874-4FD5-8ED1-9A1E3E8F4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7688653-5FFD-4944-9DEE-EB1FF12AD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6548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5A83D7E-04E0-438F-98DD-D111D3354D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71FE993-5EF9-4B1C-BE45-861C8F83D3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190B824-896D-4BA5-AC4C-5B417D1C49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C41181D-5A23-477C-B4F0-6266826BFD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215720D-C9E1-4FF6-9121-7299406EF1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E93E38D5-D0E5-4B43-9C85-3725B8399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B077603-67E0-4E7F-AFD9-BAECF2559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9CBA53F7-0A58-4E2E-A812-229EC7E21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2115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8E0549B-BA52-4673-8A83-E61E73E712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428CBC73-AF53-434B-8BE7-1C226E7AB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A3AA4B9-747E-40DB-AD8D-D42149625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94AF00F-AD1B-4E40-BBAF-267C2A23AE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6123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B0E98A0-5F18-446A-98B7-09CA978E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AFE98483-85AE-4B24-82CA-E5AF66332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AA27AEB-244B-4C3A-9BC7-886FCE422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944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BC5075-8B64-4EF8-ADDE-BE3FD7B7C3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2743923-2DEF-4B61-AE97-EF01E7F681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1523EB2-EF4B-4550-BD41-29870D9886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328CF76-F73D-4E12-9D1A-631E10AD91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AFC5331-8143-443F-B344-DDF26CFDC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949E876-300D-4991-BE4E-67D481562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0027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7E696EA-5982-4A95-AD6A-DEF91D656A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B7CFCAF-AEE9-4603-9F18-C2217E069A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F83B072-33DE-4BB9-8627-87F86D7938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3F58E69-27FD-4B0B-870F-2BAEDA79A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5981944-39B7-491C-8D0A-6DD98DF23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FC19725-3EFB-47A6-A8C1-D0E92E7BB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923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5DFE2B9-678E-4507-A927-6FF44E01F3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77A9FD6-6102-41AD-98E8-7DCF6C738C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4082E7A-F9CF-441B-964F-843C98EF7C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A59097-0A71-492C-A30F-00D7B48F96D1}" type="datetimeFigureOut">
              <a:rPr lang="ko-KR" altLang="en-US" smtClean="0"/>
              <a:t>2024-11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732D249-4085-47AA-AEF6-4CA66C8339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4CD9994-9142-4D50-B947-CF497D6400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321445-B4DF-4842-A413-4024FB6905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6723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13" Type="http://schemas.microsoft.com/office/2007/relationships/hdphoto" Target="../media/hdphoto6.wdp"/><Relationship Id="rId18" Type="http://schemas.openxmlformats.org/officeDocument/2006/relationships/image" Target="../media/image22.png"/><Relationship Id="rId3" Type="http://schemas.microsoft.com/office/2007/relationships/hdphoto" Target="../media/hdphoto2.wdp"/><Relationship Id="rId21" Type="http://schemas.microsoft.com/office/2007/relationships/hdphoto" Target="../media/hdphoto10.wdp"/><Relationship Id="rId7" Type="http://schemas.openxmlformats.org/officeDocument/2006/relationships/image" Target="../media/image16.png"/><Relationship Id="rId12" Type="http://schemas.openxmlformats.org/officeDocument/2006/relationships/image" Target="../media/image19.png"/><Relationship Id="rId17" Type="http://schemas.microsoft.com/office/2007/relationships/hdphoto" Target="../media/hdphoto8.wdp"/><Relationship Id="rId2" Type="http://schemas.openxmlformats.org/officeDocument/2006/relationships/image" Target="../media/image13.png"/><Relationship Id="rId16" Type="http://schemas.openxmlformats.org/officeDocument/2006/relationships/image" Target="../media/image21.png"/><Relationship Id="rId20" Type="http://schemas.openxmlformats.org/officeDocument/2006/relationships/image" Target="../media/image23.png"/><Relationship Id="rId1" Type="http://schemas.openxmlformats.org/officeDocument/2006/relationships/slideLayout" Target="../slideLayouts/slideLayout1.xml"/><Relationship Id="rId6" Type="http://schemas.microsoft.com/office/2007/relationships/hdphoto" Target="../media/hdphoto3.wdp"/><Relationship Id="rId11" Type="http://schemas.microsoft.com/office/2007/relationships/hdphoto" Target="../media/hdphoto5.wdp"/><Relationship Id="rId5" Type="http://schemas.openxmlformats.org/officeDocument/2006/relationships/image" Target="../media/image15.png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18.png"/><Relationship Id="rId19" Type="http://schemas.microsoft.com/office/2007/relationships/hdphoto" Target="../media/hdphoto9.wdp"/><Relationship Id="rId4" Type="http://schemas.openxmlformats.org/officeDocument/2006/relationships/image" Target="../media/image14.png"/><Relationship Id="rId9" Type="http://schemas.openxmlformats.org/officeDocument/2006/relationships/image" Target="../media/image17.png"/><Relationship Id="rId14" Type="http://schemas.openxmlformats.org/officeDocument/2006/relationships/image" Target="../media/image20.png"/><Relationship Id="rId22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4815E9E8-8F72-4B48-A517-94B0E27BF1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094846">
            <a:off x="2761343" y="-351972"/>
            <a:ext cx="6553200" cy="67246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3523582" y="2272881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52410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DA71E6A2-219A-4462-A4F3-ED8F3B0743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215061">
            <a:off x="4056062" y="148771"/>
            <a:ext cx="5857875" cy="58674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d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068642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F98D2CAA-0B10-465B-ADA8-9D902E6CB263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 rot="20215061">
            <a:off x="4043363" y="-485775"/>
            <a:ext cx="6010275" cy="60007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d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90134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C053520B-B3DD-4982-80B6-E94F5752176C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 rot="20215061">
            <a:off x="3716338" y="-60325"/>
            <a:ext cx="5876925" cy="55054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d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138596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762196C6-39CA-45A0-A59C-03186A2D78AA}"/>
              </a:ext>
            </a:extLst>
          </p:cNvPr>
          <p:cNvGrpSpPr/>
          <p:nvPr/>
        </p:nvGrpSpPr>
        <p:grpSpPr>
          <a:xfrm>
            <a:off x="1864657" y="-184006"/>
            <a:ext cx="8587344" cy="6969150"/>
            <a:chOff x="1864657" y="-184006"/>
            <a:chExt cx="8587344" cy="6969150"/>
          </a:xfrm>
        </p:grpSpPr>
        <p:sp>
          <p:nvSpPr>
            <p:cNvPr id="20" name="TextBox 19"/>
            <p:cNvSpPr txBox="1"/>
            <p:nvPr/>
          </p:nvSpPr>
          <p:spPr>
            <a:xfrm>
              <a:off x="5022378" y="-184006"/>
              <a:ext cx="268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i="1" dirty="0">
                  <a:latin typeface="Arial" panose="020B0604020202020204" pitchFamily="34" charset="0"/>
                  <a:cs typeface="Arial" panose="020B0604020202020204" pitchFamily="34" charset="0"/>
                </a:rPr>
                <a:t>Aldh1l1</a:t>
              </a:r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-EGFP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744749" y="-184006"/>
              <a:ext cx="268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 / </a:t>
              </a:r>
              <a:r>
                <a:rPr lang="en-US" altLang="ko-KR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  <a:endParaRPr lang="ko-KR" altLang="en-US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1248324" y="867166"/>
              <a:ext cx="160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1248323" y="2511270"/>
              <a:ext cx="160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p18KD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1248324" y="4155374"/>
              <a:ext cx="160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p27KD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1248324" y="5799478"/>
              <a:ext cx="160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Double KD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300007" y="-184006"/>
              <a:ext cx="2682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H2B Tag-RFP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A0117C29-2FEE-4D77-9AB8-8BD5B205042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735222" y="234752"/>
              <a:ext cx="2716779" cy="1627200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74FAD82A-BE37-4FF6-8F7A-5CA9E2B469B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86850" y="234752"/>
              <a:ext cx="2714625" cy="1628775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96FD02BA-894F-4B4B-9891-3D64F4B6891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06274" y="234752"/>
              <a:ext cx="2714625" cy="1628775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6BEC167F-09FC-448A-8789-3DD0CB13E7A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733068" y="1881002"/>
              <a:ext cx="2716779" cy="1627200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7DA61AAA-9F4F-4C0C-8386-FE083AD25E4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285772" y="1881002"/>
              <a:ext cx="2716779" cy="1627200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2A7A1387-3CEA-4D32-B3CA-53E15225E4A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11075" y="1881002"/>
              <a:ext cx="2714625" cy="1628775"/>
            </a:xfrm>
            <a:prstGeom prst="rect">
              <a:avLst/>
            </a:prstGeom>
          </p:spPr>
        </p:pic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10FD265F-9634-40F8-8BF0-B1142F35988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733068" y="3517727"/>
              <a:ext cx="2714625" cy="1628775"/>
            </a:xfrm>
            <a:prstGeom prst="rect">
              <a:avLst/>
            </a:prstGeom>
          </p:spPr>
        </p:pic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752998B9-BB6D-4A68-8D94-416951C439A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284772" y="3517727"/>
              <a:ext cx="2714625" cy="1628775"/>
            </a:xfrm>
            <a:prstGeom prst="rect">
              <a:avLst/>
            </a:prstGeom>
          </p:spPr>
        </p:pic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C2DEFF6E-8715-4D78-AB5D-8A8BCB2DF90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13683" y="3517727"/>
              <a:ext cx="2714625" cy="1628775"/>
            </a:xfrm>
            <a:prstGeom prst="rect">
              <a:avLst/>
            </a:prstGeom>
          </p:spPr>
        </p:pic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9C81AE38-48A9-4388-B6EC-39B3DD3709CA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733068" y="5156369"/>
              <a:ext cx="2714625" cy="1628775"/>
            </a:xfrm>
            <a:prstGeom prst="rect">
              <a:avLst/>
            </a:prstGeom>
          </p:spPr>
        </p:pic>
        <p:pic>
          <p:nvPicPr>
            <p:cNvPr id="16" name="그림 15">
              <a:extLst>
                <a:ext uri="{FF2B5EF4-FFF2-40B4-BE49-F238E27FC236}">
                  <a16:creationId xmlns:a16="http://schemas.microsoft.com/office/drawing/2014/main" id="{8B9642B8-E39E-4A4B-B89F-7446E4D89048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284771" y="5156369"/>
              <a:ext cx="2714625" cy="1628775"/>
            </a:xfrm>
            <a:prstGeom prst="rect">
              <a:avLst/>
            </a:prstGeom>
          </p:spPr>
        </p:pic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772D0C90-6344-4D8A-B2A6-51AF2C563440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13682" y="5156369"/>
              <a:ext cx="2714625" cy="1628775"/>
            </a:xfrm>
            <a:prstGeom prst="rect">
              <a:avLst/>
            </a:prstGeom>
          </p:spPr>
        </p:pic>
        <p:cxnSp>
          <p:nvCxnSpPr>
            <p:cNvPr id="49" name="직선 연결선 48"/>
            <p:cNvCxnSpPr/>
            <p:nvPr/>
          </p:nvCxnSpPr>
          <p:spPr>
            <a:xfrm>
              <a:off x="2335421" y="339946"/>
              <a:ext cx="777600" cy="8165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87965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37A473F-32E7-3B4A-AA3C-5B329C81354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798C7AA7-8096-BBD5-8A37-978A82D4FB94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 rot="20094846">
            <a:off x="2802395" y="-612741"/>
            <a:ext cx="6115050" cy="65913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F03C287-30DE-8D0C-F1A0-64292FBA5F0B}"/>
              </a:ext>
            </a:extLst>
          </p:cNvPr>
          <p:cNvSpPr txBox="1"/>
          <p:nvPr/>
        </p:nvSpPr>
        <p:spPr>
          <a:xfrm>
            <a:off x="0" y="0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A866B3BA-76FA-4386-521D-232C60D12F0B}"/>
              </a:ext>
            </a:extLst>
          </p:cNvPr>
          <p:cNvSpPr/>
          <p:nvPr/>
        </p:nvSpPr>
        <p:spPr>
          <a:xfrm>
            <a:off x="3523582" y="2272881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55265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614A74B-AB33-5C8C-14B2-2ADDF9DB80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A627F46D-86AB-5F39-1611-455CE6F7AB35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0000"/>
                    </a14:imgEffect>
                    <a14:imgEffect>
                      <a14:brightnessContrast bright="10000" contrast="-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20094846">
            <a:off x="3238768" y="-300"/>
            <a:ext cx="5734050" cy="627697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1E4803C-5B5D-C91B-07A8-C52F86384AEA}"/>
              </a:ext>
            </a:extLst>
          </p:cNvPr>
          <p:cNvSpPr txBox="1"/>
          <p:nvPr/>
        </p:nvSpPr>
        <p:spPr>
          <a:xfrm>
            <a:off x="0" y="0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1E503A59-65CF-53DA-9986-4152F00E7B38}"/>
              </a:ext>
            </a:extLst>
          </p:cNvPr>
          <p:cNvSpPr/>
          <p:nvPr/>
        </p:nvSpPr>
        <p:spPr>
          <a:xfrm>
            <a:off x="3523582" y="2272881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08717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9013F63C-7EEF-4716-BEA6-16CA064EE7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092026">
            <a:off x="3082017" y="347662"/>
            <a:ext cx="6438900" cy="589597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18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90052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D42D9BF0-6F17-4DF5-AC1C-D9A08BDE0AE0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 rot="19092026">
            <a:off x="3952637" y="102308"/>
            <a:ext cx="5695950" cy="54292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18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43845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24D8BE05-26B0-4AAD-92CE-91AF4F93949B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 rot="19092026">
            <a:off x="3203902" y="-278547"/>
            <a:ext cx="6753225" cy="64389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18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95197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427A77FB-EAE3-4EC3-B1AA-5F42A82C8F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878054">
            <a:off x="4094162" y="517524"/>
            <a:ext cx="5705475" cy="56197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27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90697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32A32AF9-013A-4EF2-AD0D-CEC7396019DC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 rot="19878054">
            <a:off x="3555998" y="63047"/>
            <a:ext cx="6705600" cy="60388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27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2074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DB93ED93-4A8A-4085-92C3-5F2478697FD9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 rot="19878054">
            <a:off x="3765549" y="170672"/>
            <a:ext cx="5905500" cy="56007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5-E16_p27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8247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47</Words>
  <Application>Microsoft Office PowerPoint</Application>
  <PresentationFormat>와이드스크린</PresentationFormat>
  <Paragraphs>19</Paragraphs>
  <Slides>1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3</vt:i4>
      </vt:variant>
    </vt:vector>
  </HeadingPairs>
  <TitlesOfParts>
    <vt:vector size="1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원영</dc:creator>
  <cp:lastModifiedBy>이 원영</cp:lastModifiedBy>
  <cp:revision>14</cp:revision>
  <dcterms:created xsi:type="dcterms:W3CDTF">2019-06-12T05:13:05Z</dcterms:created>
  <dcterms:modified xsi:type="dcterms:W3CDTF">2024-11-14T00:26:05Z</dcterms:modified>
</cp:coreProperties>
</file>